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837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35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67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161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590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796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94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598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754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903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847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219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内容占位符 5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33" t="4742" r="20688" b="7420"/>
          <a:stretch/>
        </p:blipFill>
        <p:spPr>
          <a:xfrm>
            <a:off x="2985103" y="2926822"/>
            <a:ext cx="3147927" cy="4295446"/>
          </a:xfrm>
        </p:spPr>
      </p:pic>
      <p:sp>
        <p:nvSpPr>
          <p:cNvPr id="7" name="文本框 6"/>
          <p:cNvSpPr txBox="1"/>
          <p:nvPr/>
        </p:nvSpPr>
        <p:spPr>
          <a:xfrm>
            <a:off x="1279333" y="2957836"/>
            <a:ext cx="188410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asom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complex assembl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055493" y="4744233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55493" y="4951718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48"/>
          <p:cNvSpPr txBox="1"/>
          <p:nvPr/>
        </p:nvSpPr>
        <p:spPr>
          <a:xfrm>
            <a:off x="6055493" y="5155985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129636" y="3166894"/>
            <a:ext cx="9795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respir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504794" y="3382809"/>
            <a:ext cx="16140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misfolded protei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815917" y="3586338"/>
            <a:ext cx="228470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Ubiquitin-dependent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a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1688" y="4430123"/>
            <a:ext cx="258108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rograd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, vesicle recycling within Golgi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099717" y="3806275"/>
            <a:ext cx="204304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 to Golgi vesicle-mediated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10757" y="4626675"/>
            <a:ext cx="9795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coneogen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21037" y="3996234"/>
            <a:ext cx="204434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drogen ion transmembrane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072571" y="4205292"/>
            <a:ext cx="205209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 synthesis coupled proton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501611" y="4840933"/>
            <a:ext cx="161660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ediated transform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126462" y="5047906"/>
            <a:ext cx="198102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972424" y="5272737"/>
            <a:ext cx="21748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iratory chain complex I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019801" y="5467406"/>
            <a:ext cx="105123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II vesicle coa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71884" y="5671349"/>
            <a:ext cx="291839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on-transporting ATP synth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x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72287" y="5886778"/>
            <a:ext cx="232606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H dehydrogenase (ubiquinone)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974041" y="6069961"/>
            <a:ext cx="228533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biquinol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ytochrome-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80390" y="6312723"/>
            <a:ext cx="233056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r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, transferring acy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72287" y="6502609"/>
            <a:ext cx="243557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on-transporting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 synth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242913" y="6714708"/>
            <a:ext cx="198538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molec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rase activity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039687" y="6922752"/>
            <a:ext cx="115292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balt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971578" y="7162479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26"/>
          <p:cNvSpPr txBox="1"/>
          <p:nvPr/>
        </p:nvSpPr>
        <p:spPr>
          <a:xfrm>
            <a:off x="3491060" y="7170392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6"/>
          <p:cNvSpPr txBox="1"/>
          <p:nvPr/>
        </p:nvSpPr>
        <p:spPr>
          <a:xfrm>
            <a:off x="4021185" y="7166900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26"/>
          <p:cNvSpPr txBox="1"/>
          <p:nvPr/>
        </p:nvSpPr>
        <p:spPr>
          <a:xfrm>
            <a:off x="4508596" y="7167792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48"/>
          <p:cNvSpPr txBox="1"/>
          <p:nvPr/>
        </p:nvSpPr>
        <p:spPr>
          <a:xfrm>
            <a:off x="3882313" y="7403377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26"/>
          <p:cNvSpPr txBox="1"/>
          <p:nvPr/>
        </p:nvSpPr>
        <p:spPr>
          <a:xfrm>
            <a:off x="5038721" y="7172489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26"/>
          <p:cNvSpPr txBox="1"/>
          <p:nvPr/>
        </p:nvSpPr>
        <p:spPr>
          <a:xfrm>
            <a:off x="5498598" y="7170362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48"/>
          <p:cNvSpPr txBox="1"/>
          <p:nvPr/>
        </p:nvSpPr>
        <p:spPr>
          <a:xfrm>
            <a:off x="3060150" y="2570850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"/>
          <p:cNvSpPr txBox="1"/>
          <p:nvPr/>
        </p:nvSpPr>
        <p:spPr>
          <a:xfrm flipH="1">
            <a:off x="-1" y="322299"/>
            <a:ext cx="130241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7</a:t>
            </a:r>
            <a:endParaRPr lang="en-US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500080" y="2980063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498147" y="317430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098235" y="3400694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977750" y="3605472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930992" y="3812238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688513" y="4024658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614394" y="423479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555098" y="4431291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494486" y="4637190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363545" y="4852847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340874" y="506359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377055" y="527380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465328" y="5482480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424839" y="5690334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734317" y="589772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555099" y="6102637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426125" y="6320445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3423651" y="6518085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3423553" y="6725298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350551" y="6932773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637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26</Words>
  <Application>Microsoft Office PowerPoint</Application>
  <PresentationFormat>自定义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4:57Z</dcterms:modified>
</cp:coreProperties>
</file>